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7AA657-687E-4156-8521-CF7658F3570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DFAED9-17C4-48D6-915B-2DCEBE9FECA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F97C32-91C2-4507-A945-540211120C9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2D3DFA-EA17-4F3E-BB6B-3F2A758B5F8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50C19D-414E-45B3-984B-FAAB6FF0C5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BD22D9-F71F-43D5-9191-6F74AF88BC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6BF5F8-80AE-49B8-A45C-31813BC868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4D3354-4F20-4BC8-833D-EC4A406B6D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D27054-5FCC-47D2-B956-21E2ACB512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B350B8-A836-4F9F-BFDC-9FE15D8F9E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51C98C-5495-4DD5-AD0B-96B1E764AB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A10114-8EDF-4686-83AF-5EE88DFF75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2940929-390E-4268-816C-F7851567619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image" Target="../media/image2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Object 9"/>
          <p:cNvGraphicFramePr/>
          <p:nvPr/>
        </p:nvGraphicFramePr>
        <p:xfrm>
          <a:off x="1368360" y="2414520"/>
          <a:ext cx="2952720" cy="172728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Object 9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368360" y="2414520"/>
                    <a:ext cx="2952720" cy="1727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Text Box 15"/>
          <p:cNvSpPr/>
          <p:nvPr/>
        </p:nvSpPr>
        <p:spPr>
          <a:xfrm rot="16200000">
            <a:off x="-1177920" y="3116160"/>
            <a:ext cx="4875480" cy="35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lnSpc>
                <a:spcPct val="7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CCL5 Extracellular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 rtl="1">
              <a:lnSpc>
                <a:spcPct val="7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Expression (pg/10</a:t>
            </a:r>
            <a:r>
              <a:rPr b="1" lang="en-US" sz="900" spc="-1" strike="noStrike" baseline="30000">
                <a:solidFill>
                  <a:srgbClr val="000000"/>
                </a:solidFill>
                <a:latin typeface="Arial"/>
              </a:rPr>
              <a:t>7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 cells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19"/>
          <p:cNvSpPr/>
          <p:nvPr/>
        </p:nvSpPr>
        <p:spPr>
          <a:xfrm>
            <a:off x="2155680" y="3865680"/>
            <a:ext cx="504036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-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                            IL-1</a:t>
            </a:r>
            <a:r>
              <a:rPr b="1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br>
              <a:rPr sz="1000"/>
            </a:b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                       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00 pg/m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30"/>
          <p:cNvSpPr/>
          <p:nvPr/>
        </p:nvSpPr>
        <p:spPr>
          <a:xfrm>
            <a:off x="1042920" y="2116080"/>
            <a:ext cx="1085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. T47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34"/>
          <p:cNvSpPr/>
          <p:nvPr/>
        </p:nvSpPr>
        <p:spPr>
          <a:xfrm>
            <a:off x="3424320" y="2435400"/>
            <a:ext cx="718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25"/>
          <p:cNvSpPr/>
          <p:nvPr/>
        </p:nvSpPr>
        <p:spPr>
          <a:xfrm>
            <a:off x="5910120" y="6154560"/>
            <a:ext cx="2305080" cy="370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Chart 14" descr=""/>
          <p:cNvPicPr/>
          <p:nvPr/>
        </p:nvPicPr>
        <p:blipFill>
          <a:blip r:embed="rId3"/>
          <a:stretch/>
        </p:blipFill>
        <p:spPr>
          <a:xfrm>
            <a:off x="4925880" y="2170080"/>
            <a:ext cx="2846520" cy="2090880"/>
          </a:xfrm>
          <a:prstGeom prst="rect">
            <a:avLst/>
          </a:prstGeom>
          <a:ln w="0">
            <a:noFill/>
          </a:ln>
        </p:spPr>
      </p:pic>
      <p:sp>
        <p:nvSpPr>
          <p:cNvPr id="49" name="Text Box 15"/>
          <p:cNvSpPr/>
          <p:nvPr/>
        </p:nvSpPr>
        <p:spPr>
          <a:xfrm rot="16200000">
            <a:off x="3758040" y="3112200"/>
            <a:ext cx="2016360" cy="35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lnSpc>
                <a:spcPct val="7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CCL5 Extracellular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 rtl="1">
              <a:lnSpc>
                <a:spcPct val="7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Expression (pg/10</a:t>
            </a:r>
            <a:r>
              <a:rPr b="1" lang="en-US" sz="900" spc="-1" strike="noStrike" baseline="30000">
                <a:solidFill>
                  <a:srgbClr val="000000"/>
                </a:solidFill>
                <a:latin typeface="Arial"/>
              </a:rPr>
              <a:t>7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 cells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30"/>
          <p:cNvSpPr/>
          <p:nvPr/>
        </p:nvSpPr>
        <p:spPr>
          <a:xfrm>
            <a:off x="4514760" y="2133720"/>
            <a:ext cx="108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. MCF-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26"/>
          <p:cNvSpPr/>
          <p:nvPr/>
        </p:nvSpPr>
        <p:spPr>
          <a:xfrm>
            <a:off x="6510240" y="3900600"/>
            <a:ext cx="12384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NF</a:t>
            </a:r>
            <a:r>
              <a:rPr b="1" lang="el-GR" sz="1000" spc="-1" strike="noStrike">
                <a:solidFill>
                  <a:srgbClr val="000000"/>
                </a:solidFill>
                <a:latin typeface="Calibri"/>
              </a:rPr>
              <a:t>α</a:t>
            </a:r>
            <a:br>
              <a:rPr sz="1000"/>
            </a:b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00 U/m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27"/>
          <p:cNvSpPr/>
          <p:nvPr/>
        </p:nvSpPr>
        <p:spPr>
          <a:xfrm>
            <a:off x="5311800" y="3862440"/>
            <a:ext cx="1239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34"/>
          <p:cNvSpPr/>
          <p:nvPr/>
        </p:nvSpPr>
        <p:spPr>
          <a:xfrm>
            <a:off x="6932520" y="2525760"/>
            <a:ext cx="719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**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5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8-14T07:51:00Z</dcterms:created>
  <dc:creator>aditbnb</dc:creator>
  <dc:description/>
  <dc:language>en-US</dc:language>
  <cp:lastModifiedBy>AditBNB1</cp:lastModifiedBy>
  <dcterms:modified xsi:type="dcterms:W3CDTF">2011-03-30T06:51:51Z</dcterms:modified>
  <cp:revision>126</cp:revision>
  <dc:subject/>
  <dc:title>Slide 1</dc:title>
</cp:coreProperties>
</file>